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7"/>
  </p:notesMasterIdLst>
  <p:sldIdLst>
    <p:sldId id="260" r:id="rId2"/>
    <p:sldId id="256" r:id="rId3"/>
    <p:sldId id="257" r:id="rId4"/>
    <p:sldId id="258" r:id="rId5"/>
    <p:sldId id="259" r:id="rId6"/>
  </p:sldIdLst>
  <p:sldSz cx="6659563" cy="6480175"/>
  <p:notesSz cx="6858000" cy="9144000"/>
  <p:embeddedFontLst>
    <p:embeddedFont>
      <p:font typeface="Calibri" panose="020F0502020204030204" pitchFamily="34" charset="0"/>
      <p:regular r:id="rId8"/>
      <p:bold r:id="rId9"/>
      <p:italic r:id="rId10"/>
      <p:boldItalic r:id="rId11"/>
    </p:embeddedFont>
    <p:embeddedFont>
      <p:font typeface="Helvetica Neue" panose="020B0604020202020204" charset="0"/>
      <p:regular r:id="rId12"/>
      <p:bold r:id="rId13"/>
      <p:italic r:id="rId14"/>
      <p:boldItalic r:id="rId1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jYccDz2Q8l9KD94i097wt2aZFUa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8"/>
  </p:normalViewPr>
  <p:slideViewPr>
    <p:cSldViewPr snapToGrid="0">
      <p:cViewPr varScale="1">
        <p:scale>
          <a:sx n="77" d="100"/>
          <a:sy n="77" d="100"/>
        </p:scale>
        <p:origin x="1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1.fntdata"/><Relationship Id="rId13" Type="http://schemas.openxmlformats.org/officeDocument/2006/relationships/font" Target="fonts/font6.fntdata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font" Target="fonts/font5.fntdata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4.fntdata"/><Relationship Id="rId5" Type="http://schemas.openxmlformats.org/officeDocument/2006/relationships/slide" Target="slides/slide4.xml"/><Relationship Id="rId15" Type="http://schemas.openxmlformats.org/officeDocument/2006/relationships/font" Target="fonts/font8.fntdata"/><Relationship Id="rId10" Type="http://schemas.openxmlformats.org/officeDocument/2006/relationships/font" Target="fonts/font3.fntdata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font" Target="fonts/font2.fntdata"/><Relationship Id="rId14" Type="http://schemas.openxmlformats.org/officeDocument/2006/relationships/font" Target="fonts/font7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843088" y="1143000"/>
            <a:ext cx="31718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43088" y="1143000"/>
            <a:ext cx="31718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/>
              <a:t>Glycogen in liver</a:t>
            </a:r>
            <a:endParaRPr/>
          </a:p>
        </p:txBody>
      </p:sp>
      <p:sp>
        <p:nvSpPr>
          <p:cNvPr id="87" name="Google Shape;87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2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43088" y="1143000"/>
            <a:ext cx="31718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9" name="Google Shape;109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/>
              <a:t>Glycogen in liver</a:t>
            </a:r>
            <a:endParaRPr/>
          </a:p>
        </p:txBody>
      </p:sp>
      <p:sp>
        <p:nvSpPr>
          <p:cNvPr id="110" name="Google Shape;110;p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3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2" name="Google Shape;132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43088" y="1143000"/>
            <a:ext cx="31718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2" name="Google Shape;142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843088" y="1143000"/>
            <a:ext cx="31718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razno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6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6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6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aslov i okomiti teks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5"/>
          <p:cNvSpPr txBox="1">
            <a:spLocks noGrp="1"/>
          </p:cNvSpPr>
          <p:nvPr>
            <p:ph type="title"/>
          </p:nvPr>
        </p:nvSpPr>
        <p:spPr>
          <a:xfrm>
            <a:off x="457845" y="345011"/>
            <a:ext cx="5743873" cy="12525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5"/>
          <p:cNvSpPr txBox="1">
            <a:spLocks noGrp="1"/>
          </p:cNvSpPr>
          <p:nvPr>
            <p:ph type="body" idx="1"/>
          </p:nvPr>
        </p:nvSpPr>
        <p:spPr>
          <a:xfrm rot="5400000">
            <a:off x="1273976" y="908916"/>
            <a:ext cx="4111612" cy="57438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5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5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5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komiti naslov i teks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6"/>
          <p:cNvSpPr txBox="1">
            <a:spLocks noGrp="1"/>
          </p:cNvSpPr>
          <p:nvPr>
            <p:ph type="title"/>
          </p:nvPr>
        </p:nvSpPr>
        <p:spPr>
          <a:xfrm rot="5400000">
            <a:off x="2737909" y="2372850"/>
            <a:ext cx="5491649" cy="14359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6"/>
          <p:cNvSpPr txBox="1">
            <a:spLocks noGrp="1"/>
          </p:cNvSpPr>
          <p:nvPr>
            <p:ph type="body" idx="1"/>
          </p:nvPr>
        </p:nvSpPr>
        <p:spPr>
          <a:xfrm rot="5400000">
            <a:off x="-175650" y="978504"/>
            <a:ext cx="5491649" cy="42246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6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6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6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aslovni slajd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7"/>
          <p:cNvSpPr txBox="1">
            <a:spLocks noGrp="1"/>
          </p:cNvSpPr>
          <p:nvPr>
            <p:ph type="ctrTitle"/>
          </p:nvPr>
        </p:nvSpPr>
        <p:spPr>
          <a:xfrm>
            <a:off x="499467" y="1060529"/>
            <a:ext cx="5660629" cy="22560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370"/>
              <a:buFont typeface="Calibri"/>
              <a:buNone/>
              <a:defRPr sz="437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7"/>
          <p:cNvSpPr txBox="1">
            <a:spLocks noGrp="1"/>
          </p:cNvSpPr>
          <p:nvPr>
            <p:ph type="subTitle" idx="1"/>
          </p:nvPr>
        </p:nvSpPr>
        <p:spPr>
          <a:xfrm>
            <a:off x="832446" y="3403592"/>
            <a:ext cx="4994672" cy="15645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748"/>
              <a:buNone/>
              <a:defRPr sz="1748"/>
            </a:lvl1pPr>
            <a:lvl2pPr lvl="1" algn="ctr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None/>
              <a:defRPr sz="1457"/>
            </a:lvl2pPr>
            <a:lvl3pPr lvl="2" algn="ctr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None/>
              <a:defRPr sz="1311"/>
            </a:lvl3pPr>
            <a:lvl4pPr lvl="3" algn="ctr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/>
            </a:lvl4pPr>
            <a:lvl5pPr lvl="4" algn="ctr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/>
            </a:lvl5pPr>
            <a:lvl6pPr lvl="5" algn="ctr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/>
            </a:lvl6pPr>
            <a:lvl7pPr lvl="6" algn="ctr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/>
            </a:lvl7pPr>
            <a:lvl8pPr lvl="7" algn="ctr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/>
            </a:lvl8pPr>
            <a:lvl9pPr lvl="8" algn="ctr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/>
            </a:lvl9pPr>
          </a:lstStyle>
          <a:p>
            <a:endParaRPr/>
          </a:p>
        </p:txBody>
      </p:sp>
      <p:sp>
        <p:nvSpPr>
          <p:cNvPr id="22" name="Google Shape;22;p7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7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7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aslov i sadržaj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8"/>
          <p:cNvSpPr txBox="1">
            <a:spLocks noGrp="1"/>
          </p:cNvSpPr>
          <p:nvPr>
            <p:ph type="title"/>
          </p:nvPr>
        </p:nvSpPr>
        <p:spPr>
          <a:xfrm>
            <a:off x="457845" y="345011"/>
            <a:ext cx="5743873" cy="12525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8"/>
          <p:cNvSpPr txBox="1">
            <a:spLocks noGrp="1"/>
          </p:cNvSpPr>
          <p:nvPr>
            <p:ph type="body" idx="1"/>
          </p:nvPr>
        </p:nvSpPr>
        <p:spPr>
          <a:xfrm>
            <a:off x="457845" y="1725046"/>
            <a:ext cx="5743873" cy="41116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8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8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8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aglavlje sekcije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9"/>
          <p:cNvSpPr txBox="1">
            <a:spLocks noGrp="1"/>
          </p:cNvSpPr>
          <p:nvPr>
            <p:ph type="title"/>
          </p:nvPr>
        </p:nvSpPr>
        <p:spPr>
          <a:xfrm>
            <a:off x="454377" y="1615546"/>
            <a:ext cx="5743873" cy="26955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370"/>
              <a:buFont typeface="Calibri"/>
              <a:buNone/>
              <a:defRPr sz="437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9"/>
          <p:cNvSpPr txBox="1">
            <a:spLocks noGrp="1"/>
          </p:cNvSpPr>
          <p:nvPr>
            <p:ph type="body" idx="1"/>
          </p:nvPr>
        </p:nvSpPr>
        <p:spPr>
          <a:xfrm>
            <a:off x="454377" y="4336619"/>
            <a:ext cx="5743873" cy="14175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748"/>
              <a:buNone/>
              <a:defRPr sz="1748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rgbClr val="888888"/>
              </a:buClr>
              <a:buSzPts val="1457"/>
              <a:buNone/>
              <a:defRPr sz="1457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rgbClr val="888888"/>
              </a:buClr>
              <a:buSzPts val="1311"/>
              <a:buNone/>
              <a:defRPr sz="1311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rgbClr val="888888"/>
              </a:buClr>
              <a:buSzPts val="1165"/>
              <a:buNone/>
              <a:defRPr sz="1165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rgbClr val="888888"/>
              </a:buClr>
              <a:buSzPts val="1165"/>
              <a:buNone/>
              <a:defRPr sz="1165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rgbClr val="888888"/>
              </a:buClr>
              <a:buSzPts val="1165"/>
              <a:buNone/>
              <a:defRPr sz="1165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rgbClr val="888888"/>
              </a:buClr>
              <a:buSzPts val="1165"/>
              <a:buNone/>
              <a:defRPr sz="1165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rgbClr val="888888"/>
              </a:buClr>
              <a:buSzPts val="1165"/>
              <a:buNone/>
              <a:defRPr sz="1165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rgbClr val="888888"/>
              </a:buClr>
              <a:buSzPts val="1165"/>
              <a:buNone/>
              <a:defRPr sz="1165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9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9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va sadržaja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0"/>
          <p:cNvSpPr txBox="1">
            <a:spLocks noGrp="1"/>
          </p:cNvSpPr>
          <p:nvPr>
            <p:ph type="title"/>
          </p:nvPr>
        </p:nvSpPr>
        <p:spPr>
          <a:xfrm>
            <a:off x="457845" y="345011"/>
            <a:ext cx="5743873" cy="12525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body" idx="1"/>
          </p:nvPr>
        </p:nvSpPr>
        <p:spPr>
          <a:xfrm>
            <a:off x="457845" y="1725046"/>
            <a:ext cx="2830314" cy="41116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0"/>
          <p:cNvSpPr txBox="1">
            <a:spLocks noGrp="1"/>
          </p:cNvSpPr>
          <p:nvPr>
            <p:ph type="body" idx="2"/>
          </p:nvPr>
        </p:nvSpPr>
        <p:spPr>
          <a:xfrm>
            <a:off x="3371404" y="1725046"/>
            <a:ext cx="2830314" cy="41116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0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Usporedba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/>
          </p:nvPr>
        </p:nvSpPr>
        <p:spPr>
          <a:xfrm>
            <a:off x="458712" y="345011"/>
            <a:ext cx="5743873" cy="12525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458713" y="1588543"/>
            <a:ext cx="2817307" cy="7785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748"/>
              <a:buNone/>
              <a:defRPr sz="1748" b="1"/>
            </a:lvl1pPr>
            <a:lvl2pPr marL="914400" lvl="1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None/>
              <a:defRPr sz="1457" b="1"/>
            </a:lvl2pPr>
            <a:lvl3pPr marL="1371600" lvl="2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None/>
              <a:defRPr sz="1311" b="1"/>
            </a:lvl3pPr>
            <a:lvl4pPr marL="1828800" lvl="3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4pPr>
            <a:lvl5pPr marL="2286000" lvl="4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5pPr>
            <a:lvl6pPr marL="2743200" lvl="5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6pPr>
            <a:lvl7pPr marL="3200400" lvl="6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7pPr>
            <a:lvl8pPr marL="3657600" lvl="7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8pPr>
            <a:lvl9pPr marL="4114800" lvl="8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body" idx="2"/>
          </p:nvPr>
        </p:nvSpPr>
        <p:spPr>
          <a:xfrm>
            <a:off x="458713" y="2367064"/>
            <a:ext cx="2817307" cy="34815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body" idx="3"/>
          </p:nvPr>
        </p:nvSpPr>
        <p:spPr>
          <a:xfrm>
            <a:off x="3371404" y="1588543"/>
            <a:ext cx="2831182" cy="7785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748"/>
              <a:buNone/>
              <a:defRPr sz="1748" b="1"/>
            </a:lvl1pPr>
            <a:lvl2pPr marL="914400" lvl="1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None/>
              <a:defRPr sz="1457" b="1"/>
            </a:lvl2pPr>
            <a:lvl3pPr marL="1371600" lvl="2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None/>
              <a:defRPr sz="1311" b="1"/>
            </a:lvl3pPr>
            <a:lvl4pPr marL="1828800" lvl="3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4pPr>
            <a:lvl5pPr marL="2286000" lvl="4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5pPr>
            <a:lvl6pPr marL="2743200" lvl="5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6pPr>
            <a:lvl7pPr marL="3200400" lvl="6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7pPr>
            <a:lvl8pPr marL="3657600" lvl="7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8pPr>
            <a:lvl9pPr marL="4114800" lvl="8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 b="1"/>
            </a:lvl9pPr>
          </a:lstStyle>
          <a:p>
            <a:endParaRPr/>
          </a:p>
        </p:txBody>
      </p:sp>
      <p:sp>
        <p:nvSpPr>
          <p:cNvPr id="49" name="Google Shape;49;p11"/>
          <p:cNvSpPr txBox="1">
            <a:spLocks noGrp="1"/>
          </p:cNvSpPr>
          <p:nvPr>
            <p:ph type="body" idx="4"/>
          </p:nvPr>
        </p:nvSpPr>
        <p:spPr>
          <a:xfrm>
            <a:off x="3371404" y="2367064"/>
            <a:ext cx="2831182" cy="34815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1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1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1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amo naslov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2"/>
          <p:cNvSpPr txBox="1">
            <a:spLocks noGrp="1"/>
          </p:cNvSpPr>
          <p:nvPr>
            <p:ph type="title"/>
          </p:nvPr>
        </p:nvSpPr>
        <p:spPr>
          <a:xfrm>
            <a:off x="457845" y="345011"/>
            <a:ext cx="5743873" cy="12525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2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2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2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adržaj s opisom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3"/>
          <p:cNvSpPr txBox="1">
            <a:spLocks noGrp="1"/>
          </p:cNvSpPr>
          <p:nvPr>
            <p:ph type="title"/>
          </p:nvPr>
        </p:nvSpPr>
        <p:spPr>
          <a:xfrm>
            <a:off x="458713" y="432012"/>
            <a:ext cx="2147882" cy="15120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31"/>
              <a:buFont typeface="Calibri"/>
              <a:buNone/>
              <a:defRPr sz="233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body" idx="1"/>
          </p:nvPr>
        </p:nvSpPr>
        <p:spPr>
          <a:xfrm>
            <a:off x="2831182" y="933027"/>
            <a:ext cx="3371404" cy="46051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76618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2331"/>
              <a:buChar char="•"/>
              <a:defRPr sz="2331"/>
            </a:lvl1pPr>
            <a:lvl2pPr marL="914400" lvl="1" indent="-358076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2039"/>
              <a:buChar char="•"/>
              <a:defRPr sz="2039"/>
            </a:lvl2pPr>
            <a:lvl3pPr marL="1371600" lvl="2" indent="-339597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748"/>
              <a:buChar char="•"/>
              <a:defRPr sz="1748"/>
            </a:lvl3pPr>
            <a:lvl4pPr marL="1828800" lvl="3" indent="-321119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Char char="•"/>
              <a:defRPr sz="1457"/>
            </a:lvl4pPr>
            <a:lvl5pPr marL="2286000" lvl="4" indent="-321119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Char char="•"/>
              <a:defRPr sz="1457"/>
            </a:lvl5pPr>
            <a:lvl6pPr marL="2743200" lvl="5" indent="-321119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Char char="•"/>
              <a:defRPr sz="1457"/>
            </a:lvl6pPr>
            <a:lvl7pPr marL="3200400" lvl="6" indent="-321119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Char char="•"/>
              <a:defRPr sz="1457"/>
            </a:lvl7pPr>
            <a:lvl8pPr marL="3657600" lvl="7" indent="-321119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Char char="•"/>
              <a:defRPr sz="1457"/>
            </a:lvl8pPr>
            <a:lvl9pPr marL="4114800" lvl="8" indent="-321119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Char char="•"/>
              <a:defRPr sz="1457"/>
            </a:lvl9pPr>
          </a:lstStyle>
          <a:p>
            <a:endParaRPr/>
          </a:p>
        </p:txBody>
      </p:sp>
      <p:sp>
        <p:nvSpPr>
          <p:cNvPr id="61" name="Google Shape;61;p13"/>
          <p:cNvSpPr txBox="1">
            <a:spLocks noGrp="1"/>
          </p:cNvSpPr>
          <p:nvPr>
            <p:ph type="body" idx="2"/>
          </p:nvPr>
        </p:nvSpPr>
        <p:spPr>
          <a:xfrm>
            <a:off x="458713" y="1944052"/>
            <a:ext cx="2147882" cy="36015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/>
            </a:lvl1pPr>
            <a:lvl2pPr marL="914400" lvl="1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020"/>
              <a:buNone/>
              <a:defRPr sz="1020"/>
            </a:lvl2pPr>
            <a:lvl3pPr marL="1371600" lvl="2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874"/>
              <a:buNone/>
              <a:defRPr sz="874"/>
            </a:lvl3pPr>
            <a:lvl4pPr marL="1828800" lvl="3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4pPr>
            <a:lvl5pPr marL="2286000" lvl="4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5pPr>
            <a:lvl6pPr marL="2743200" lvl="5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6pPr>
            <a:lvl7pPr marL="3200400" lvl="6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7pPr>
            <a:lvl8pPr marL="3657600" lvl="7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8pPr>
            <a:lvl9pPr marL="4114800" lvl="8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9pPr>
          </a:lstStyle>
          <a:p>
            <a:endParaRPr/>
          </a:p>
        </p:txBody>
      </p:sp>
      <p:sp>
        <p:nvSpPr>
          <p:cNvPr id="62" name="Google Shape;62;p13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3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3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lika s opisom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4"/>
          <p:cNvSpPr txBox="1">
            <a:spLocks noGrp="1"/>
          </p:cNvSpPr>
          <p:nvPr>
            <p:ph type="title"/>
          </p:nvPr>
        </p:nvSpPr>
        <p:spPr>
          <a:xfrm>
            <a:off x="458713" y="432012"/>
            <a:ext cx="2147882" cy="15120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31"/>
              <a:buFont typeface="Calibri"/>
              <a:buNone/>
              <a:defRPr sz="233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>
            <a:spLocks noGrp="1"/>
          </p:cNvSpPr>
          <p:nvPr>
            <p:ph type="pic" idx="2"/>
          </p:nvPr>
        </p:nvSpPr>
        <p:spPr>
          <a:xfrm>
            <a:off x="2831182" y="933027"/>
            <a:ext cx="3371404" cy="4605124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4"/>
          <p:cNvSpPr txBox="1">
            <a:spLocks noGrp="1"/>
          </p:cNvSpPr>
          <p:nvPr>
            <p:ph type="body" idx="1"/>
          </p:nvPr>
        </p:nvSpPr>
        <p:spPr>
          <a:xfrm>
            <a:off x="458713" y="1944052"/>
            <a:ext cx="2147882" cy="36015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1165"/>
              <a:buNone/>
              <a:defRPr sz="1165"/>
            </a:lvl1pPr>
            <a:lvl2pPr marL="914400" lvl="1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020"/>
              <a:buNone/>
              <a:defRPr sz="1020"/>
            </a:lvl2pPr>
            <a:lvl3pPr marL="1371600" lvl="2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874"/>
              <a:buNone/>
              <a:defRPr sz="874"/>
            </a:lvl3pPr>
            <a:lvl4pPr marL="1828800" lvl="3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4pPr>
            <a:lvl5pPr marL="2286000" lvl="4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5pPr>
            <a:lvl6pPr marL="2743200" lvl="5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6pPr>
            <a:lvl7pPr marL="3200400" lvl="6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7pPr>
            <a:lvl8pPr marL="3657600" lvl="7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8pPr>
            <a:lvl9pPr marL="4114800" lvl="8" indent="-228600" algn="l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728"/>
              <a:buNone/>
              <a:defRPr sz="728"/>
            </a:lvl9pPr>
          </a:lstStyle>
          <a:p>
            <a:endParaRPr/>
          </a:p>
        </p:txBody>
      </p:sp>
      <p:sp>
        <p:nvSpPr>
          <p:cNvPr id="69" name="Google Shape;69;p14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4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4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5"/>
          <p:cNvSpPr txBox="1">
            <a:spLocks noGrp="1"/>
          </p:cNvSpPr>
          <p:nvPr>
            <p:ph type="title"/>
          </p:nvPr>
        </p:nvSpPr>
        <p:spPr>
          <a:xfrm>
            <a:off x="457845" y="345011"/>
            <a:ext cx="5743873" cy="12525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5"/>
              <a:buFont typeface="Calibri"/>
              <a:buNone/>
              <a:defRPr sz="320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5"/>
          <p:cNvSpPr txBox="1">
            <a:spLocks noGrp="1"/>
          </p:cNvSpPr>
          <p:nvPr>
            <p:ph type="body" idx="1"/>
          </p:nvPr>
        </p:nvSpPr>
        <p:spPr>
          <a:xfrm>
            <a:off x="457845" y="1725046"/>
            <a:ext cx="5743873" cy="41116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58076" algn="l" rtl="0">
              <a:lnSpc>
                <a:spcPct val="90000"/>
              </a:lnSpc>
              <a:spcBef>
                <a:spcPts val="728"/>
              </a:spcBef>
              <a:spcAft>
                <a:spcPts val="0"/>
              </a:spcAft>
              <a:buClr>
                <a:schemeClr val="dk1"/>
              </a:buClr>
              <a:buSzPts val="2039"/>
              <a:buFont typeface="Arial"/>
              <a:buChar char="•"/>
              <a:defRPr sz="203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39597" algn="l" rtl="0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748"/>
              <a:buFont typeface="Arial"/>
              <a:buChar char="•"/>
              <a:defRPr sz="174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1119" algn="l" rtl="0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457"/>
              <a:buFont typeface="Arial"/>
              <a:buChar char="•"/>
              <a:defRPr sz="145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1848" algn="l" rtl="0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Font typeface="Arial"/>
              <a:buChar char="•"/>
              <a:defRPr sz="131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1848" algn="l" rtl="0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Font typeface="Arial"/>
              <a:buChar char="•"/>
              <a:defRPr sz="131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1848" algn="l" rtl="0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Font typeface="Arial"/>
              <a:buChar char="•"/>
              <a:defRPr sz="131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1848" algn="l" rtl="0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Font typeface="Arial"/>
              <a:buChar char="•"/>
              <a:defRPr sz="131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1848" algn="l" rtl="0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Font typeface="Arial"/>
              <a:buChar char="•"/>
              <a:defRPr sz="131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1848" algn="l" rtl="0">
              <a:lnSpc>
                <a:spcPct val="90000"/>
              </a:lnSpc>
              <a:spcBef>
                <a:spcPts val="364"/>
              </a:spcBef>
              <a:spcAft>
                <a:spcPts val="0"/>
              </a:spcAft>
              <a:buClr>
                <a:schemeClr val="dk1"/>
              </a:buClr>
              <a:buSzPts val="1311"/>
              <a:buFont typeface="Arial"/>
              <a:buChar char="•"/>
              <a:defRPr sz="131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5"/>
          <p:cNvSpPr txBox="1">
            <a:spLocks noGrp="1"/>
          </p:cNvSpPr>
          <p:nvPr>
            <p:ph type="dt" idx="10"/>
          </p:nvPr>
        </p:nvSpPr>
        <p:spPr>
          <a:xfrm>
            <a:off x="457845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5"/>
          <p:cNvSpPr txBox="1">
            <a:spLocks noGrp="1"/>
          </p:cNvSpPr>
          <p:nvPr>
            <p:ph type="ftr" idx="11"/>
          </p:nvPr>
        </p:nvSpPr>
        <p:spPr>
          <a:xfrm>
            <a:off x="2205980" y="6006164"/>
            <a:ext cx="2247603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5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5"/>
          <p:cNvSpPr txBox="1">
            <a:spLocks noGrp="1"/>
          </p:cNvSpPr>
          <p:nvPr>
            <p:ph type="sldNum" idx="12"/>
          </p:nvPr>
        </p:nvSpPr>
        <p:spPr>
          <a:xfrm>
            <a:off x="4703316" y="6006164"/>
            <a:ext cx="1498402" cy="3450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874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hr-HR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ollage of graphs and diagrams&#10;&#10;Description automatically generated">
            <a:extLst>
              <a:ext uri="{FF2B5EF4-FFF2-40B4-BE49-F238E27FC236}">
                <a16:creationId xmlns:a16="http://schemas.microsoft.com/office/drawing/2014/main" id="{ABFCB616-E47D-4A19-C91F-3377AF13B5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05559"/>
            <a:ext cx="6659563" cy="4080304"/>
          </a:xfrm>
          <a:prstGeom prst="rect">
            <a:avLst/>
          </a:prstGeom>
        </p:spPr>
      </p:pic>
      <p:sp>
        <p:nvSpPr>
          <p:cNvPr id="7" name="Google Shape;92;p1">
            <a:extLst>
              <a:ext uri="{FF2B5EF4-FFF2-40B4-BE49-F238E27FC236}">
                <a16:creationId xmlns:a16="http://schemas.microsoft.com/office/drawing/2014/main" id="{D596003C-4DC3-DC1C-2511-4C3E9BF8AEDA}"/>
              </a:ext>
            </a:extLst>
          </p:cNvPr>
          <p:cNvSpPr/>
          <p:nvPr/>
        </p:nvSpPr>
        <p:spPr>
          <a:xfrm>
            <a:off x="191000" y="4185863"/>
            <a:ext cx="6075410" cy="23082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100" b="1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xtended data figure 5.1. </a:t>
            </a:r>
            <a:r>
              <a:rPr lang="hr-HR" sz="110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igh serum cholesterol was associated with HFHSD fed male groups. Interaction plots of intervention and sex effects on the following parameters: A) serum cholesterol (mM) and triglycerides (mM); B) serum aspartate transaminase (AST) and alanine transaminase (ALT) (IU/L); C) liver mass to body mass ratio (%) (HFHSD+L females had the highest liver mass to body mass ratio potentially indicating liver edema); D) average size of fat droplets in skeletal muscle based on Oil red O staining (pixel2); E) lipid peroxidation (LPO) (thiobarbituric acid reactive substances, TBARS) of the skeletal muscle (nmol/mg of fresh tissue weight, FW). Two-way ANOVA and Games-Howell post hoc test for between-group comparisons, black symbol – experimental groups including both sexes, green symbol – male groups, red symbol – female groups, *compared to STD, †compared to HFHSD, */†p &lt; 0.05, **/††p &lt; 0.01, ***/†††p &lt; 0.001. Abbreviations: NS – not significant, f – female, m – male, STD – standard diet group, HFHSD – high-fat high-sucrose diet group, HFHSD+M – HFHSD treated with metformin, HFHSD+L – HFHSD treated with liraglutide</a:t>
            </a:r>
            <a:r>
              <a:rPr lang="hr-HR" sz="120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. 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828892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Google Shape;89;p1" descr="A close-up of a tile floor&#10;&#10;Description automatically generated with low confidenc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86790" y="405218"/>
            <a:ext cx="5192521" cy="3931072"/>
          </a:xfrm>
          <a:prstGeom prst="rect">
            <a:avLst/>
          </a:prstGeom>
          <a:noFill/>
          <a:ln>
            <a:noFill/>
          </a:ln>
        </p:spPr>
      </p:pic>
      <p:sp>
        <p:nvSpPr>
          <p:cNvPr id="90" name="Google Shape;90;p1"/>
          <p:cNvSpPr txBox="1"/>
          <p:nvPr/>
        </p:nvSpPr>
        <p:spPr>
          <a:xfrm>
            <a:off x="1462023" y="200743"/>
            <a:ext cx="4704355" cy="256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600" b="1" i="0" u="none" strike="noStrike" cap="none" baseline="30000">
                <a:solidFill>
                  <a:schemeClr val="accent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STD </a:t>
            </a:r>
            <a:r>
              <a:rPr lang="hr-HR" sz="1600" b="1" i="0" u="none" strike="noStrike" cap="none" baseline="300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                   </a:t>
            </a:r>
            <a:r>
              <a:rPr lang="hr-HR" sz="1600" b="1" i="0" u="none" strike="noStrike" cap="none" baseline="30000">
                <a:solidFill>
                  <a:schemeClr val="accent2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</a:t>
            </a:r>
            <a:r>
              <a:rPr lang="hr-HR" sz="1600" b="1" i="0" u="none" strike="noStrike" cap="none" baseline="300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                 </a:t>
            </a:r>
            <a:r>
              <a:rPr lang="hr-HR" sz="1600" b="1" i="0" u="none" strike="noStrike" cap="none" baseline="30000">
                <a:solidFill>
                  <a:srgbClr val="7F7F7F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+M                </a:t>
            </a:r>
            <a:r>
              <a:rPr lang="hr-HR" sz="1600" b="1" i="0" u="none" strike="noStrike" cap="none" baseline="30000">
                <a:solidFill>
                  <a:srgbClr val="00B05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+L</a:t>
            </a:r>
            <a:endParaRPr sz="1600" b="1" baseline="30000">
              <a:solidFill>
                <a:srgbClr val="00B05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91" name="Google Shape;91;p1"/>
          <p:cNvSpPr/>
          <p:nvPr/>
        </p:nvSpPr>
        <p:spPr>
          <a:xfrm>
            <a:off x="276224" y="95249"/>
            <a:ext cx="6048375" cy="4362451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255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2" name="Google Shape;92;p1"/>
          <p:cNvSpPr/>
          <p:nvPr/>
        </p:nvSpPr>
        <p:spPr>
          <a:xfrm>
            <a:off x="249189" y="4558481"/>
            <a:ext cx="6075410" cy="8309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200" b="1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xtended Data figure 5.2. Liver fat droplets visualized with Oil Red O.</a:t>
            </a:r>
            <a:r>
              <a:rPr lang="hr-HR" sz="120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endParaRPr dirty="0"/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200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Abbreviations: CPL – central part of the liver, SPL – subcapsular part of the liver; STD – standard diet group, HFHSD – high-fat high-sucrose diet group, HFHSD+M – HFHSD treated with metformin, HFHSD+L – HFHSD treated with liraglutide. </a:t>
            </a:r>
            <a:endParaRPr dirty="0"/>
          </a:p>
        </p:txBody>
      </p:sp>
      <p:cxnSp>
        <p:nvCxnSpPr>
          <p:cNvPr id="93" name="Google Shape;93;p1"/>
          <p:cNvCxnSpPr/>
          <p:nvPr/>
        </p:nvCxnSpPr>
        <p:spPr>
          <a:xfrm>
            <a:off x="5786540" y="4260380"/>
            <a:ext cx="30600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94" name="Google Shape;94;p1"/>
          <p:cNvCxnSpPr/>
          <p:nvPr/>
        </p:nvCxnSpPr>
        <p:spPr>
          <a:xfrm>
            <a:off x="5786540" y="2265901"/>
            <a:ext cx="30600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95" name="Google Shape;95;p1"/>
          <p:cNvSpPr txBox="1"/>
          <p:nvPr/>
        </p:nvSpPr>
        <p:spPr>
          <a:xfrm>
            <a:off x="5722026" y="4121940"/>
            <a:ext cx="444352" cy="1846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6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200 μm</a:t>
            </a:r>
            <a:endParaRPr sz="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96" name="Google Shape;96;p1"/>
          <p:cNvGrpSpPr/>
          <p:nvPr/>
        </p:nvGrpSpPr>
        <p:grpSpPr>
          <a:xfrm>
            <a:off x="303160" y="405218"/>
            <a:ext cx="785024" cy="1951200"/>
            <a:chOff x="303160" y="405218"/>
            <a:chExt cx="785024" cy="1951200"/>
          </a:xfrm>
        </p:grpSpPr>
        <p:sp>
          <p:nvSpPr>
            <p:cNvPr id="97" name="Google Shape;97;p1"/>
            <p:cNvSpPr/>
            <p:nvPr/>
          </p:nvSpPr>
          <p:spPr>
            <a:xfrm>
              <a:off x="303160" y="442967"/>
              <a:ext cx="785024" cy="39454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MALES</a:t>
              </a:r>
              <a:endParaRPr sz="800" b="1" dirty="0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98" name="Google Shape;98;p1"/>
            <p:cNvSpPr/>
            <p:nvPr/>
          </p:nvSpPr>
          <p:spPr>
            <a:xfrm>
              <a:off x="513162" y="837512"/>
              <a:ext cx="476233" cy="18137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SPL</a:t>
              </a:r>
              <a:endParaRPr sz="8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99" name="Google Shape;99;p1"/>
            <p:cNvSpPr/>
            <p:nvPr/>
          </p:nvSpPr>
          <p:spPr>
            <a:xfrm>
              <a:off x="513162" y="1719845"/>
              <a:ext cx="476233" cy="251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CPL</a:t>
              </a:r>
              <a:endParaRPr sz="8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00" name="Google Shape;100;p1"/>
            <p:cNvSpPr/>
            <p:nvPr/>
          </p:nvSpPr>
          <p:spPr>
            <a:xfrm>
              <a:off x="406215" y="405218"/>
              <a:ext cx="540000" cy="1951200"/>
            </a:xfrm>
            <a:prstGeom prst="rect">
              <a:avLst/>
            </a:prstGeom>
            <a:noFill/>
            <a:ln w="12700" cap="flat" cmpd="sng">
              <a:solidFill>
                <a:srgbClr val="A5A5A5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55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101" name="Google Shape;101;p1"/>
          <p:cNvGrpSpPr/>
          <p:nvPr/>
        </p:nvGrpSpPr>
        <p:grpSpPr>
          <a:xfrm>
            <a:off x="311111" y="2378265"/>
            <a:ext cx="785024" cy="1951200"/>
            <a:chOff x="311111" y="405218"/>
            <a:chExt cx="785024" cy="1951200"/>
          </a:xfrm>
        </p:grpSpPr>
        <p:sp>
          <p:nvSpPr>
            <p:cNvPr id="102" name="Google Shape;102;p1"/>
            <p:cNvSpPr/>
            <p:nvPr/>
          </p:nvSpPr>
          <p:spPr>
            <a:xfrm>
              <a:off x="311111" y="442967"/>
              <a:ext cx="785024" cy="39454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>
                  <a:solidFill>
                    <a:srgbClr val="FF0000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FEMALES</a:t>
              </a:r>
              <a:endParaRPr sz="800" b="1">
                <a:solidFill>
                  <a:srgbClr val="FF0000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03" name="Google Shape;103;p1"/>
            <p:cNvSpPr/>
            <p:nvPr/>
          </p:nvSpPr>
          <p:spPr>
            <a:xfrm>
              <a:off x="513162" y="837512"/>
              <a:ext cx="476233" cy="18137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SPL</a:t>
              </a:r>
              <a:endParaRPr sz="8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04" name="Google Shape;104;p1"/>
            <p:cNvSpPr/>
            <p:nvPr/>
          </p:nvSpPr>
          <p:spPr>
            <a:xfrm>
              <a:off x="513162" y="1719845"/>
              <a:ext cx="476233" cy="251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CPL</a:t>
              </a:r>
              <a:endParaRPr sz="8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05" name="Google Shape;105;p1"/>
            <p:cNvSpPr/>
            <p:nvPr/>
          </p:nvSpPr>
          <p:spPr>
            <a:xfrm>
              <a:off x="406215" y="405218"/>
              <a:ext cx="540000" cy="1951200"/>
            </a:xfrm>
            <a:prstGeom prst="rect">
              <a:avLst/>
            </a:prstGeom>
            <a:noFill/>
            <a:ln w="12700" cap="flat" cmpd="sng">
              <a:solidFill>
                <a:srgbClr val="A5A5A5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55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106" name="Google Shape;106;p1"/>
          <p:cNvSpPr txBox="1"/>
          <p:nvPr/>
        </p:nvSpPr>
        <p:spPr>
          <a:xfrm>
            <a:off x="5708902" y="2128595"/>
            <a:ext cx="444352" cy="1846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6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200 μm</a:t>
            </a:r>
            <a:endParaRPr sz="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Google Shape;112;p2" descr="Background pattern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77737" y="397177"/>
            <a:ext cx="5183701" cy="3954684"/>
          </a:xfrm>
          <a:prstGeom prst="rect">
            <a:avLst/>
          </a:prstGeom>
          <a:noFill/>
          <a:ln>
            <a:noFill/>
          </a:ln>
        </p:spPr>
      </p:pic>
      <p:sp>
        <p:nvSpPr>
          <p:cNvPr id="113" name="Google Shape;113;p2"/>
          <p:cNvSpPr txBox="1"/>
          <p:nvPr/>
        </p:nvSpPr>
        <p:spPr>
          <a:xfrm>
            <a:off x="1462023" y="200743"/>
            <a:ext cx="4704355" cy="256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600" b="1" baseline="30000">
                <a:solidFill>
                  <a:schemeClr val="accent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STD </a:t>
            </a:r>
            <a:r>
              <a:rPr lang="hr-HR" sz="1600" b="1" baseline="300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                   </a:t>
            </a:r>
            <a:r>
              <a:rPr lang="hr-HR" sz="1600" b="1" baseline="30000">
                <a:solidFill>
                  <a:schemeClr val="accent2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</a:t>
            </a:r>
            <a:r>
              <a:rPr lang="hr-HR" sz="1600" b="1" baseline="300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                 </a:t>
            </a:r>
            <a:r>
              <a:rPr lang="hr-HR" sz="1600" b="1" baseline="30000">
                <a:solidFill>
                  <a:srgbClr val="7F7F7F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+M                </a:t>
            </a:r>
            <a:r>
              <a:rPr lang="hr-HR" sz="1600" b="1" baseline="30000">
                <a:solidFill>
                  <a:srgbClr val="00B05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+L</a:t>
            </a:r>
            <a:endParaRPr sz="1600" b="1" baseline="30000">
              <a:solidFill>
                <a:srgbClr val="00B05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14" name="Google Shape;114;p2"/>
          <p:cNvSpPr/>
          <p:nvPr/>
        </p:nvSpPr>
        <p:spPr>
          <a:xfrm>
            <a:off x="276224" y="95249"/>
            <a:ext cx="6048375" cy="4362451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255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5" name="Google Shape;115;p2"/>
          <p:cNvSpPr/>
          <p:nvPr/>
        </p:nvSpPr>
        <p:spPr>
          <a:xfrm>
            <a:off x="249189" y="4558481"/>
            <a:ext cx="6075410" cy="8309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2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xtended Data figure 5.3. Metachromatic toluidine stain of liver for glycogen.</a:t>
            </a:r>
            <a:r>
              <a:rPr lang="hr-HR" sz="12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Abbreviations: CPL – central part of the liver, SPL – subcapsular part of the liver; STD – standard diet group, HFHSD – high-fat high-sucrose diet group, HFHSD+M – HFHSD treated with metformin, HFHSD+L – HFHSD treated with liraglutide. </a:t>
            </a:r>
            <a:endParaRPr/>
          </a:p>
        </p:txBody>
      </p:sp>
      <p:sp>
        <p:nvSpPr>
          <p:cNvPr id="116" name="Google Shape;116;p2"/>
          <p:cNvSpPr txBox="1"/>
          <p:nvPr/>
        </p:nvSpPr>
        <p:spPr>
          <a:xfrm>
            <a:off x="5700528" y="2127543"/>
            <a:ext cx="444352" cy="1846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6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100 μm</a:t>
            </a:r>
            <a:endParaRPr sz="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17" name="Google Shape;117;p2"/>
          <p:cNvCxnSpPr/>
          <p:nvPr/>
        </p:nvCxnSpPr>
        <p:spPr>
          <a:xfrm>
            <a:off x="5769704" y="4264396"/>
            <a:ext cx="30600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grpSp>
        <p:nvGrpSpPr>
          <p:cNvPr id="118" name="Google Shape;118;p2"/>
          <p:cNvGrpSpPr/>
          <p:nvPr/>
        </p:nvGrpSpPr>
        <p:grpSpPr>
          <a:xfrm>
            <a:off x="303160" y="396165"/>
            <a:ext cx="785024" cy="1951200"/>
            <a:chOff x="303160" y="405218"/>
            <a:chExt cx="785024" cy="1951200"/>
          </a:xfrm>
        </p:grpSpPr>
        <p:sp>
          <p:nvSpPr>
            <p:cNvPr id="119" name="Google Shape;119;p2"/>
            <p:cNvSpPr/>
            <p:nvPr/>
          </p:nvSpPr>
          <p:spPr>
            <a:xfrm>
              <a:off x="303160" y="442967"/>
              <a:ext cx="785024" cy="39454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MALES</a:t>
              </a:r>
              <a:endParaRPr sz="800" b="1" dirty="0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20" name="Google Shape;120;p2"/>
            <p:cNvSpPr/>
            <p:nvPr/>
          </p:nvSpPr>
          <p:spPr>
            <a:xfrm>
              <a:off x="513162" y="837512"/>
              <a:ext cx="476233" cy="18137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SPL</a:t>
              </a:r>
              <a:endParaRPr sz="8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21" name="Google Shape;121;p2"/>
            <p:cNvSpPr/>
            <p:nvPr/>
          </p:nvSpPr>
          <p:spPr>
            <a:xfrm>
              <a:off x="513162" y="1719845"/>
              <a:ext cx="476233" cy="251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CPL</a:t>
              </a:r>
              <a:endParaRPr sz="8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22" name="Google Shape;122;p2"/>
            <p:cNvSpPr/>
            <p:nvPr/>
          </p:nvSpPr>
          <p:spPr>
            <a:xfrm>
              <a:off x="406215" y="405218"/>
              <a:ext cx="540000" cy="1951200"/>
            </a:xfrm>
            <a:prstGeom prst="rect">
              <a:avLst/>
            </a:prstGeom>
            <a:noFill/>
            <a:ln w="12700" cap="flat" cmpd="sng">
              <a:solidFill>
                <a:srgbClr val="A5A5A5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55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123" name="Google Shape;123;p2"/>
          <p:cNvGrpSpPr/>
          <p:nvPr/>
        </p:nvGrpSpPr>
        <p:grpSpPr>
          <a:xfrm>
            <a:off x="311111" y="2394167"/>
            <a:ext cx="785024" cy="1951200"/>
            <a:chOff x="311111" y="405218"/>
            <a:chExt cx="785024" cy="1951200"/>
          </a:xfrm>
        </p:grpSpPr>
        <p:sp>
          <p:nvSpPr>
            <p:cNvPr id="124" name="Google Shape;124;p2"/>
            <p:cNvSpPr/>
            <p:nvPr/>
          </p:nvSpPr>
          <p:spPr>
            <a:xfrm>
              <a:off x="311111" y="442967"/>
              <a:ext cx="785024" cy="39454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>
                  <a:solidFill>
                    <a:srgbClr val="FF0000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FEMALES</a:t>
              </a:r>
              <a:endParaRPr sz="800" b="1">
                <a:solidFill>
                  <a:srgbClr val="FF0000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25" name="Google Shape;125;p2"/>
            <p:cNvSpPr/>
            <p:nvPr/>
          </p:nvSpPr>
          <p:spPr>
            <a:xfrm>
              <a:off x="513162" y="837512"/>
              <a:ext cx="476233" cy="18137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SPL</a:t>
              </a:r>
              <a:endParaRPr sz="8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26" name="Google Shape;126;p2"/>
            <p:cNvSpPr/>
            <p:nvPr/>
          </p:nvSpPr>
          <p:spPr>
            <a:xfrm>
              <a:off x="513162" y="1719845"/>
              <a:ext cx="476233" cy="251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6000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hr-HR" sz="800" b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CPL</a:t>
              </a:r>
              <a:endParaRPr sz="8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127" name="Google Shape;127;p2"/>
            <p:cNvSpPr/>
            <p:nvPr/>
          </p:nvSpPr>
          <p:spPr>
            <a:xfrm>
              <a:off x="406215" y="405218"/>
              <a:ext cx="540000" cy="1951200"/>
            </a:xfrm>
            <a:prstGeom prst="rect">
              <a:avLst/>
            </a:prstGeom>
            <a:noFill/>
            <a:ln w="12700" cap="flat" cmpd="sng">
              <a:solidFill>
                <a:srgbClr val="A5A5A5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255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cxnSp>
        <p:nvCxnSpPr>
          <p:cNvPr id="128" name="Google Shape;128;p2"/>
          <p:cNvCxnSpPr/>
          <p:nvPr/>
        </p:nvCxnSpPr>
        <p:spPr>
          <a:xfrm>
            <a:off x="5769704" y="2277896"/>
            <a:ext cx="306000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29" name="Google Shape;129;p2"/>
          <p:cNvSpPr txBox="1"/>
          <p:nvPr/>
        </p:nvSpPr>
        <p:spPr>
          <a:xfrm>
            <a:off x="5690879" y="4109945"/>
            <a:ext cx="444352" cy="1846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6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100 μm</a:t>
            </a:r>
            <a:endParaRPr sz="6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3"/>
          <p:cNvSpPr txBox="1"/>
          <p:nvPr/>
        </p:nvSpPr>
        <p:spPr>
          <a:xfrm>
            <a:off x="387654" y="2726065"/>
            <a:ext cx="5971500" cy="138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4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xtended Data figure </a:t>
            </a:r>
            <a:r>
              <a:rPr lang="hr-HR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5</a:t>
            </a:r>
            <a:r>
              <a:rPr lang="hr-HR" sz="14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.4. Succinate dehydrogenase staining of skeletal muscle. </a:t>
            </a:r>
            <a:r>
              <a:rPr lang="hr-HR" sz="14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Intensely stained muscle fibers are type I, moderately stained muscle fibers are type IIA, weakly stained muscle fibers are type IIB. Abbreviations: STD – standard diet group, HFHSD – high-fat high-sucrose diet group, HFHSD+M – HFHSD treated with metformin, HFHSD+L – HFHSD treated with liraglutide.</a:t>
            </a:r>
            <a:r>
              <a:rPr lang="hr-HR" sz="14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endParaRPr sz="1255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5" name="Google Shape;135;p3" descr="A picture containing stone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26785" y="579471"/>
            <a:ext cx="5426381" cy="2062356"/>
          </a:xfrm>
          <a:prstGeom prst="rect">
            <a:avLst/>
          </a:prstGeom>
          <a:noFill/>
          <a:ln>
            <a:noFill/>
          </a:ln>
        </p:spPr>
      </p:pic>
      <p:sp>
        <p:nvSpPr>
          <p:cNvPr id="136" name="Google Shape;136;p3"/>
          <p:cNvSpPr txBox="1"/>
          <p:nvPr/>
        </p:nvSpPr>
        <p:spPr>
          <a:xfrm>
            <a:off x="1324741" y="322991"/>
            <a:ext cx="4704355" cy="256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600" b="1" baseline="30000">
                <a:solidFill>
                  <a:schemeClr val="accent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STD </a:t>
            </a:r>
            <a:r>
              <a:rPr lang="hr-HR" sz="1600" b="1" baseline="300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                   </a:t>
            </a:r>
            <a:r>
              <a:rPr lang="hr-HR" sz="1600" b="1" baseline="30000">
                <a:solidFill>
                  <a:schemeClr val="accent2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</a:t>
            </a:r>
            <a:r>
              <a:rPr lang="hr-HR" sz="1600" b="1" baseline="300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                 </a:t>
            </a:r>
            <a:r>
              <a:rPr lang="hr-HR" sz="1600" b="1" baseline="30000">
                <a:solidFill>
                  <a:srgbClr val="7F7F7F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+M                </a:t>
            </a:r>
            <a:r>
              <a:rPr lang="hr-HR" sz="1600" b="1" baseline="30000">
                <a:solidFill>
                  <a:srgbClr val="00B05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+L</a:t>
            </a:r>
            <a:endParaRPr sz="1600" b="1" baseline="30000">
              <a:solidFill>
                <a:srgbClr val="00B05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37" name="Google Shape;137;p3"/>
          <p:cNvSpPr/>
          <p:nvPr/>
        </p:nvSpPr>
        <p:spPr>
          <a:xfrm>
            <a:off x="387654" y="251312"/>
            <a:ext cx="5884253" cy="2474753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255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8" name="Google Shape;138;p3"/>
          <p:cNvSpPr/>
          <p:nvPr/>
        </p:nvSpPr>
        <p:spPr>
          <a:xfrm rot="-5400000">
            <a:off x="89055" y="977477"/>
            <a:ext cx="1012011" cy="216000"/>
          </a:xfrm>
          <a:prstGeom prst="rect">
            <a:avLst/>
          </a:prstGeom>
          <a:noFill/>
          <a:ln w="12700" cap="flat" cmpd="sng">
            <a:solidFill>
              <a:srgbClr val="A5A5A5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800" b="1" noProof="1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ales</a:t>
            </a:r>
            <a:endParaRPr lang="hr-HR" b="1" noProof="1">
              <a:solidFill>
                <a:schemeClr val="tx1"/>
              </a:solidFill>
            </a:endParaRPr>
          </a:p>
        </p:txBody>
      </p:sp>
      <p:sp>
        <p:nvSpPr>
          <p:cNvPr id="139" name="Google Shape;139;p3"/>
          <p:cNvSpPr/>
          <p:nvPr/>
        </p:nvSpPr>
        <p:spPr>
          <a:xfrm rot="-5400000">
            <a:off x="89055" y="2027822"/>
            <a:ext cx="1012011" cy="216000"/>
          </a:xfrm>
          <a:prstGeom prst="rect">
            <a:avLst/>
          </a:prstGeom>
          <a:noFill/>
          <a:ln w="12700" cap="flat" cmpd="sng">
            <a:solidFill>
              <a:srgbClr val="A5A5A5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800" b="1" noProof="1">
                <a:solidFill>
                  <a:srgbClr val="FF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emales</a:t>
            </a:r>
            <a:endParaRPr lang="hr-HR" b="1" noProof="1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4" name="Google Shape;144;p4" descr="A picture containing text, fabric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37528" y="581212"/>
            <a:ext cx="5450106" cy="2071373"/>
          </a:xfrm>
          <a:prstGeom prst="rect">
            <a:avLst/>
          </a:prstGeom>
          <a:noFill/>
          <a:ln>
            <a:noFill/>
          </a:ln>
        </p:spPr>
      </p:pic>
      <p:sp>
        <p:nvSpPr>
          <p:cNvPr id="145" name="Google Shape;145;p4"/>
          <p:cNvSpPr txBox="1"/>
          <p:nvPr/>
        </p:nvSpPr>
        <p:spPr>
          <a:xfrm>
            <a:off x="344088" y="2726065"/>
            <a:ext cx="5971500" cy="95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4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xtended Data figure </a:t>
            </a:r>
            <a:r>
              <a:rPr lang="hr-HR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5</a:t>
            </a:r>
            <a:r>
              <a:rPr lang="hr-HR" sz="14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.5. Oil red O staining of skeletal muscle. </a:t>
            </a:r>
            <a:r>
              <a:rPr lang="hr-HR" sz="14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Abbreviations: STD – standard diet group, HFHSD – high-fat high-sucrose diet group, HFHSD+M – HFHSD treated with metformin, HFHSD+L – HFHSD treated with liraglutide.</a:t>
            </a:r>
            <a:r>
              <a:rPr lang="hr-HR" sz="14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</a:t>
            </a:r>
            <a:endParaRPr sz="1255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6" name="Google Shape;146;p4"/>
          <p:cNvSpPr txBox="1"/>
          <p:nvPr/>
        </p:nvSpPr>
        <p:spPr>
          <a:xfrm>
            <a:off x="1324741" y="322991"/>
            <a:ext cx="4704355" cy="2564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1600" b="1" baseline="30000">
                <a:solidFill>
                  <a:schemeClr val="accent5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STD </a:t>
            </a:r>
            <a:r>
              <a:rPr lang="hr-HR" sz="1600" b="1" baseline="300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                   </a:t>
            </a:r>
            <a:r>
              <a:rPr lang="hr-HR" sz="1600" b="1" baseline="30000">
                <a:solidFill>
                  <a:schemeClr val="accent2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</a:t>
            </a:r>
            <a:r>
              <a:rPr lang="hr-HR" sz="1600" b="1" baseline="3000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                  </a:t>
            </a:r>
            <a:r>
              <a:rPr lang="hr-HR" sz="1600" b="1" baseline="30000">
                <a:solidFill>
                  <a:srgbClr val="7F7F7F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+M                </a:t>
            </a:r>
            <a:r>
              <a:rPr lang="hr-HR" sz="1600" b="1" baseline="30000">
                <a:solidFill>
                  <a:srgbClr val="00B05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HFHSD+L</a:t>
            </a:r>
            <a:endParaRPr sz="1600" b="1" baseline="30000">
              <a:solidFill>
                <a:srgbClr val="00B05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47" name="Google Shape;147;p4"/>
          <p:cNvSpPr/>
          <p:nvPr/>
        </p:nvSpPr>
        <p:spPr>
          <a:xfrm>
            <a:off x="387654" y="251312"/>
            <a:ext cx="5884253" cy="2474753"/>
          </a:xfrm>
          <a:prstGeom prst="rect">
            <a:avLst/>
          </a:prstGeom>
          <a:noFill/>
          <a:ln w="12700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255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8" name="Google Shape;148;p4"/>
          <p:cNvSpPr/>
          <p:nvPr/>
        </p:nvSpPr>
        <p:spPr>
          <a:xfrm rot="-5400000">
            <a:off x="89055" y="977477"/>
            <a:ext cx="1012011" cy="216000"/>
          </a:xfrm>
          <a:prstGeom prst="rect">
            <a:avLst/>
          </a:prstGeom>
          <a:noFill/>
          <a:ln w="12700" cap="flat" cmpd="sng">
            <a:solidFill>
              <a:srgbClr val="A5A5A5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800" b="1" noProof="1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ales</a:t>
            </a:r>
            <a:endParaRPr lang="hr-HR" b="1" noProof="1">
              <a:solidFill>
                <a:schemeClr val="tx1"/>
              </a:solidFill>
            </a:endParaRPr>
          </a:p>
        </p:txBody>
      </p:sp>
      <p:sp>
        <p:nvSpPr>
          <p:cNvPr id="149" name="Google Shape;149;p4"/>
          <p:cNvSpPr/>
          <p:nvPr/>
        </p:nvSpPr>
        <p:spPr>
          <a:xfrm rot="-5400000">
            <a:off x="89055" y="2027822"/>
            <a:ext cx="1012011" cy="216000"/>
          </a:xfrm>
          <a:prstGeom prst="rect">
            <a:avLst/>
          </a:prstGeom>
          <a:noFill/>
          <a:ln w="12700" cap="flat" cmpd="sng">
            <a:solidFill>
              <a:srgbClr val="A5A5A5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hr-HR" sz="800" b="1" noProof="1">
                <a:solidFill>
                  <a:srgbClr val="FF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emales</a:t>
            </a:r>
            <a:endParaRPr lang="hr-HR" b="1" noProof="1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sustava Office">
  <a:themeElements>
    <a:clrScheme name="Tema sustava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sustava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43</Words>
  <Application>Microsoft Office PowerPoint</Application>
  <PresentationFormat>Custom</PresentationFormat>
  <Paragraphs>34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Helvetica Neue</vt:lpstr>
      <vt:lpstr>Tema sustava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drana Ivić</dc:creator>
  <cp:lastModifiedBy>Giulia Valsecchi</cp:lastModifiedBy>
  <cp:revision>3</cp:revision>
  <dcterms:created xsi:type="dcterms:W3CDTF">2020-07-02T13:02:55Z</dcterms:created>
  <dcterms:modified xsi:type="dcterms:W3CDTF">2023-09-25T12:43:16Z</dcterms:modified>
</cp:coreProperties>
</file>